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notesMasterIdLst>
    <p:notesMasterId r:id="rId3"/>
  </p:notesMasterIdLst>
  <p:sldIdLst>
    <p:sldId id="266" r:id="rId2"/>
  </p:sldIdLst>
  <p:sldSz cx="6254750" cy="84582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uppl Fig 3" id="{02D3D78A-72FF-4C17-97BE-0912DDA77A82}">
          <p14:sldIdLst>
            <p14:sldId id="266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USER" initials="U" lastIdx="9" clrIdx="0">
    <p:extLst>
      <p:ext uri="{19B8F6BF-5375-455C-9EA6-DF929625EA0E}">
        <p15:presenceInfo xmlns:p15="http://schemas.microsoft.com/office/powerpoint/2012/main" userId="USER" providerId="None"/>
      </p:ext>
    </p:extLst>
  </p:cmAuthor>
  <p:cmAuthor id="2" name="skarimi" initials="s" lastIdx="4" clrIdx="1">
    <p:extLst>
      <p:ext uri="{19B8F6BF-5375-455C-9EA6-DF929625EA0E}">
        <p15:presenceInfo xmlns:p15="http://schemas.microsoft.com/office/powerpoint/2012/main" userId="skarimi" providerId="None"/>
      </p:ext>
    </p:extLst>
  </p:cmAuthor>
  <p:cmAuthor id="3" name="soheila karimi" initials="sk" lastIdx="6" clrIdx="2">
    <p:extLst>
      <p:ext uri="{19B8F6BF-5375-455C-9EA6-DF929625EA0E}">
        <p15:presenceInfo xmlns:p15="http://schemas.microsoft.com/office/powerpoint/2012/main" userId="bb0168d6462bdfd4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AD222"/>
    <a:srgbClr val="EAB200"/>
    <a:srgbClr val="EA6B14"/>
    <a:srgbClr val="3333FF"/>
    <a:srgbClr val="00FF00"/>
    <a:srgbClr val="1DFF1D"/>
    <a:srgbClr val="000300"/>
    <a:srgbClr val="66A2D8"/>
    <a:srgbClr val="84B4E0"/>
    <a:srgbClr val="5F5FD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326" autoAdjust="0"/>
    <p:restoredTop sz="86861" autoAdjust="0"/>
  </p:normalViewPr>
  <p:slideViewPr>
    <p:cSldViewPr snapToGrid="0">
      <p:cViewPr varScale="1">
        <p:scale>
          <a:sx n="55" d="100"/>
          <a:sy n="55" d="100"/>
        </p:scale>
        <p:origin x="49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0817B45-D4D3-45CB-934D-97DF67DE9D2D}" type="datetimeFigureOut">
              <a:rPr lang="en-US" smtClean="0"/>
              <a:t>2/13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87588" y="1143000"/>
            <a:ext cx="22828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DB61A00-9F51-4288-915B-64876428BF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61738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736092" rtl="0" eaLnBrk="1" latinLnBrk="0" hangingPunct="1">
      <a:defRPr sz="966" kern="1200">
        <a:solidFill>
          <a:schemeClr val="tx1"/>
        </a:solidFill>
        <a:latin typeface="+mn-lt"/>
        <a:ea typeface="+mn-ea"/>
        <a:cs typeface="+mn-cs"/>
      </a:defRPr>
    </a:lvl1pPr>
    <a:lvl2pPr marL="368046" algn="l" defTabSz="736092" rtl="0" eaLnBrk="1" latinLnBrk="0" hangingPunct="1">
      <a:defRPr sz="966" kern="1200">
        <a:solidFill>
          <a:schemeClr val="tx1"/>
        </a:solidFill>
        <a:latin typeface="+mn-lt"/>
        <a:ea typeface="+mn-ea"/>
        <a:cs typeface="+mn-cs"/>
      </a:defRPr>
    </a:lvl2pPr>
    <a:lvl3pPr marL="736092" algn="l" defTabSz="736092" rtl="0" eaLnBrk="1" latinLnBrk="0" hangingPunct="1">
      <a:defRPr sz="966" kern="1200">
        <a:solidFill>
          <a:schemeClr val="tx1"/>
        </a:solidFill>
        <a:latin typeface="+mn-lt"/>
        <a:ea typeface="+mn-ea"/>
        <a:cs typeface="+mn-cs"/>
      </a:defRPr>
    </a:lvl3pPr>
    <a:lvl4pPr marL="1104138" algn="l" defTabSz="736092" rtl="0" eaLnBrk="1" latinLnBrk="0" hangingPunct="1">
      <a:defRPr sz="966" kern="1200">
        <a:solidFill>
          <a:schemeClr val="tx1"/>
        </a:solidFill>
        <a:latin typeface="+mn-lt"/>
        <a:ea typeface="+mn-ea"/>
        <a:cs typeface="+mn-cs"/>
      </a:defRPr>
    </a:lvl4pPr>
    <a:lvl5pPr marL="1472184" algn="l" defTabSz="736092" rtl="0" eaLnBrk="1" latinLnBrk="0" hangingPunct="1">
      <a:defRPr sz="966" kern="1200">
        <a:solidFill>
          <a:schemeClr val="tx1"/>
        </a:solidFill>
        <a:latin typeface="+mn-lt"/>
        <a:ea typeface="+mn-ea"/>
        <a:cs typeface="+mn-cs"/>
      </a:defRPr>
    </a:lvl5pPr>
    <a:lvl6pPr marL="1840230" algn="l" defTabSz="736092" rtl="0" eaLnBrk="1" latinLnBrk="0" hangingPunct="1">
      <a:defRPr sz="966" kern="1200">
        <a:solidFill>
          <a:schemeClr val="tx1"/>
        </a:solidFill>
        <a:latin typeface="+mn-lt"/>
        <a:ea typeface="+mn-ea"/>
        <a:cs typeface="+mn-cs"/>
      </a:defRPr>
    </a:lvl6pPr>
    <a:lvl7pPr marL="2208276" algn="l" defTabSz="736092" rtl="0" eaLnBrk="1" latinLnBrk="0" hangingPunct="1">
      <a:defRPr sz="966" kern="1200">
        <a:solidFill>
          <a:schemeClr val="tx1"/>
        </a:solidFill>
        <a:latin typeface="+mn-lt"/>
        <a:ea typeface="+mn-ea"/>
        <a:cs typeface="+mn-cs"/>
      </a:defRPr>
    </a:lvl7pPr>
    <a:lvl8pPr marL="2576322" algn="l" defTabSz="736092" rtl="0" eaLnBrk="1" latinLnBrk="0" hangingPunct="1">
      <a:defRPr sz="966" kern="1200">
        <a:solidFill>
          <a:schemeClr val="tx1"/>
        </a:solidFill>
        <a:latin typeface="+mn-lt"/>
        <a:ea typeface="+mn-ea"/>
        <a:cs typeface="+mn-cs"/>
      </a:defRPr>
    </a:lvl8pPr>
    <a:lvl9pPr marL="2944368" algn="l" defTabSz="736092" rtl="0" eaLnBrk="1" latinLnBrk="0" hangingPunct="1">
      <a:defRPr sz="966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69106" y="1384248"/>
            <a:ext cx="5316538" cy="2944707"/>
          </a:xfrm>
        </p:spPr>
        <p:txBody>
          <a:bodyPr anchor="b"/>
          <a:lstStyle>
            <a:lvl1pPr algn="ctr">
              <a:defRPr sz="410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81844" y="4442514"/>
            <a:ext cx="4691063" cy="2042106"/>
          </a:xfrm>
        </p:spPr>
        <p:txBody>
          <a:bodyPr/>
          <a:lstStyle>
            <a:lvl1pPr marL="0" indent="0" algn="ctr">
              <a:buNone/>
              <a:defRPr sz="1642"/>
            </a:lvl1pPr>
            <a:lvl2pPr marL="312725" indent="0" algn="ctr">
              <a:buNone/>
              <a:defRPr sz="1368"/>
            </a:lvl2pPr>
            <a:lvl3pPr marL="625450" indent="0" algn="ctr">
              <a:buNone/>
              <a:defRPr sz="1231"/>
            </a:lvl3pPr>
            <a:lvl4pPr marL="938174" indent="0" algn="ctr">
              <a:buNone/>
              <a:defRPr sz="1094"/>
            </a:lvl4pPr>
            <a:lvl5pPr marL="1250899" indent="0" algn="ctr">
              <a:buNone/>
              <a:defRPr sz="1094"/>
            </a:lvl5pPr>
            <a:lvl6pPr marL="1563624" indent="0" algn="ctr">
              <a:buNone/>
              <a:defRPr sz="1094"/>
            </a:lvl6pPr>
            <a:lvl7pPr marL="1876349" indent="0" algn="ctr">
              <a:buNone/>
              <a:defRPr sz="1094"/>
            </a:lvl7pPr>
            <a:lvl8pPr marL="2189074" indent="0" algn="ctr">
              <a:buNone/>
              <a:defRPr sz="1094"/>
            </a:lvl8pPr>
            <a:lvl9pPr marL="2501798" indent="0" algn="ctr">
              <a:buNone/>
              <a:defRPr sz="1094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583E7-35CE-4CCC-88E2-B853881ACBA0}" type="datetimeFigureOut">
              <a:rPr lang="en-US" smtClean="0"/>
              <a:t>2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7E058-FEC0-4F0D-986D-6993D1123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15675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583E7-35CE-4CCC-88E2-B853881ACBA0}" type="datetimeFigureOut">
              <a:rPr lang="en-US" smtClean="0"/>
              <a:t>2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7E058-FEC0-4F0D-986D-6993D1123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52559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476056" y="450321"/>
            <a:ext cx="1348680" cy="716793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30014" y="450321"/>
            <a:ext cx="3967857" cy="7167934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583E7-35CE-4CCC-88E2-B853881ACBA0}" type="datetimeFigureOut">
              <a:rPr lang="en-US" smtClean="0"/>
              <a:t>2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7E058-FEC0-4F0D-986D-6993D1123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9920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583E7-35CE-4CCC-88E2-B853881ACBA0}" type="datetimeFigureOut">
              <a:rPr lang="en-US" smtClean="0"/>
              <a:t>2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7E058-FEC0-4F0D-986D-6993D1123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14686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6757" y="2108679"/>
            <a:ext cx="5394722" cy="3518376"/>
          </a:xfrm>
        </p:spPr>
        <p:txBody>
          <a:bodyPr anchor="b"/>
          <a:lstStyle>
            <a:lvl1pPr>
              <a:defRPr sz="410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6757" y="5660339"/>
            <a:ext cx="5394722" cy="1850231"/>
          </a:xfrm>
        </p:spPr>
        <p:txBody>
          <a:bodyPr/>
          <a:lstStyle>
            <a:lvl1pPr marL="0" indent="0">
              <a:buNone/>
              <a:defRPr sz="1642">
                <a:solidFill>
                  <a:schemeClr val="tx1"/>
                </a:solidFill>
              </a:defRPr>
            </a:lvl1pPr>
            <a:lvl2pPr marL="312725" indent="0">
              <a:buNone/>
              <a:defRPr sz="1368">
                <a:solidFill>
                  <a:schemeClr val="tx1">
                    <a:tint val="75000"/>
                  </a:schemeClr>
                </a:solidFill>
              </a:defRPr>
            </a:lvl2pPr>
            <a:lvl3pPr marL="625450" indent="0">
              <a:buNone/>
              <a:defRPr sz="1231">
                <a:solidFill>
                  <a:schemeClr val="tx1">
                    <a:tint val="75000"/>
                  </a:schemeClr>
                </a:solidFill>
              </a:defRPr>
            </a:lvl3pPr>
            <a:lvl4pPr marL="938174" indent="0">
              <a:buNone/>
              <a:defRPr sz="1094">
                <a:solidFill>
                  <a:schemeClr val="tx1">
                    <a:tint val="75000"/>
                  </a:schemeClr>
                </a:solidFill>
              </a:defRPr>
            </a:lvl4pPr>
            <a:lvl5pPr marL="1250899" indent="0">
              <a:buNone/>
              <a:defRPr sz="1094">
                <a:solidFill>
                  <a:schemeClr val="tx1">
                    <a:tint val="75000"/>
                  </a:schemeClr>
                </a:solidFill>
              </a:defRPr>
            </a:lvl5pPr>
            <a:lvl6pPr marL="1563624" indent="0">
              <a:buNone/>
              <a:defRPr sz="1094">
                <a:solidFill>
                  <a:schemeClr val="tx1">
                    <a:tint val="75000"/>
                  </a:schemeClr>
                </a:solidFill>
              </a:defRPr>
            </a:lvl6pPr>
            <a:lvl7pPr marL="1876349" indent="0">
              <a:buNone/>
              <a:defRPr sz="1094">
                <a:solidFill>
                  <a:schemeClr val="tx1">
                    <a:tint val="75000"/>
                  </a:schemeClr>
                </a:solidFill>
              </a:defRPr>
            </a:lvl7pPr>
            <a:lvl8pPr marL="2189074" indent="0">
              <a:buNone/>
              <a:defRPr sz="1094">
                <a:solidFill>
                  <a:schemeClr val="tx1">
                    <a:tint val="75000"/>
                  </a:schemeClr>
                </a:solidFill>
              </a:defRPr>
            </a:lvl8pPr>
            <a:lvl9pPr marL="2501798" indent="0">
              <a:buNone/>
              <a:defRPr sz="109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583E7-35CE-4CCC-88E2-B853881ACBA0}" type="datetimeFigureOut">
              <a:rPr lang="en-US" smtClean="0"/>
              <a:t>2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7E058-FEC0-4F0D-986D-6993D1123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95335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30014" y="2251604"/>
            <a:ext cx="2658269" cy="536665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66467" y="2251604"/>
            <a:ext cx="2658269" cy="536665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583E7-35CE-4CCC-88E2-B853881ACBA0}" type="datetimeFigureOut">
              <a:rPr lang="en-US" smtClean="0"/>
              <a:t>2/1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7E058-FEC0-4F0D-986D-6993D1123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77309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0829" y="450323"/>
            <a:ext cx="5394722" cy="1634861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0829" y="2073434"/>
            <a:ext cx="2646052" cy="1016158"/>
          </a:xfrm>
        </p:spPr>
        <p:txBody>
          <a:bodyPr anchor="b"/>
          <a:lstStyle>
            <a:lvl1pPr marL="0" indent="0">
              <a:buNone/>
              <a:defRPr sz="1642" b="1"/>
            </a:lvl1pPr>
            <a:lvl2pPr marL="312725" indent="0">
              <a:buNone/>
              <a:defRPr sz="1368" b="1"/>
            </a:lvl2pPr>
            <a:lvl3pPr marL="625450" indent="0">
              <a:buNone/>
              <a:defRPr sz="1231" b="1"/>
            </a:lvl3pPr>
            <a:lvl4pPr marL="938174" indent="0">
              <a:buNone/>
              <a:defRPr sz="1094" b="1"/>
            </a:lvl4pPr>
            <a:lvl5pPr marL="1250899" indent="0">
              <a:buNone/>
              <a:defRPr sz="1094" b="1"/>
            </a:lvl5pPr>
            <a:lvl6pPr marL="1563624" indent="0">
              <a:buNone/>
              <a:defRPr sz="1094" b="1"/>
            </a:lvl6pPr>
            <a:lvl7pPr marL="1876349" indent="0">
              <a:buNone/>
              <a:defRPr sz="1094" b="1"/>
            </a:lvl7pPr>
            <a:lvl8pPr marL="2189074" indent="0">
              <a:buNone/>
              <a:defRPr sz="1094" b="1"/>
            </a:lvl8pPr>
            <a:lvl9pPr marL="2501798" indent="0">
              <a:buNone/>
              <a:defRPr sz="1094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0829" y="3089593"/>
            <a:ext cx="2646052" cy="454432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66468" y="2073434"/>
            <a:ext cx="2659083" cy="1016158"/>
          </a:xfrm>
        </p:spPr>
        <p:txBody>
          <a:bodyPr anchor="b"/>
          <a:lstStyle>
            <a:lvl1pPr marL="0" indent="0">
              <a:buNone/>
              <a:defRPr sz="1642" b="1"/>
            </a:lvl1pPr>
            <a:lvl2pPr marL="312725" indent="0">
              <a:buNone/>
              <a:defRPr sz="1368" b="1"/>
            </a:lvl2pPr>
            <a:lvl3pPr marL="625450" indent="0">
              <a:buNone/>
              <a:defRPr sz="1231" b="1"/>
            </a:lvl3pPr>
            <a:lvl4pPr marL="938174" indent="0">
              <a:buNone/>
              <a:defRPr sz="1094" b="1"/>
            </a:lvl4pPr>
            <a:lvl5pPr marL="1250899" indent="0">
              <a:buNone/>
              <a:defRPr sz="1094" b="1"/>
            </a:lvl5pPr>
            <a:lvl6pPr marL="1563624" indent="0">
              <a:buNone/>
              <a:defRPr sz="1094" b="1"/>
            </a:lvl6pPr>
            <a:lvl7pPr marL="1876349" indent="0">
              <a:buNone/>
              <a:defRPr sz="1094" b="1"/>
            </a:lvl7pPr>
            <a:lvl8pPr marL="2189074" indent="0">
              <a:buNone/>
              <a:defRPr sz="1094" b="1"/>
            </a:lvl8pPr>
            <a:lvl9pPr marL="2501798" indent="0">
              <a:buNone/>
              <a:defRPr sz="1094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66468" y="3089593"/>
            <a:ext cx="2659083" cy="454432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583E7-35CE-4CCC-88E2-B853881ACBA0}" type="datetimeFigureOut">
              <a:rPr lang="en-US" smtClean="0"/>
              <a:t>2/13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7E058-FEC0-4F0D-986D-6993D1123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71773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583E7-35CE-4CCC-88E2-B853881ACBA0}" type="datetimeFigureOut">
              <a:rPr lang="en-US" smtClean="0"/>
              <a:t>2/13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7E058-FEC0-4F0D-986D-6993D1123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00008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583E7-35CE-4CCC-88E2-B853881ACBA0}" type="datetimeFigureOut">
              <a:rPr lang="en-US" smtClean="0"/>
              <a:t>2/13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7E058-FEC0-4F0D-986D-6993D1123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00150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0829" y="563880"/>
            <a:ext cx="2017320" cy="1973580"/>
          </a:xfrm>
        </p:spPr>
        <p:txBody>
          <a:bodyPr anchor="b"/>
          <a:lstStyle>
            <a:lvl1pPr>
              <a:defRPr sz="218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59084" y="1217826"/>
            <a:ext cx="3166467" cy="6010804"/>
          </a:xfrm>
        </p:spPr>
        <p:txBody>
          <a:bodyPr/>
          <a:lstStyle>
            <a:lvl1pPr>
              <a:defRPr sz="2189"/>
            </a:lvl1pPr>
            <a:lvl2pPr>
              <a:defRPr sz="1915"/>
            </a:lvl2pPr>
            <a:lvl3pPr>
              <a:defRPr sz="1642"/>
            </a:lvl3pPr>
            <a:lvl4pPr>
              <a:defRPr sz="1368"/>
            </a:lvl4pPr>
            <a:lvl5pPr>
              <a:defRPr sz="1368"/>
            </a:lvl5pPr>
            <a:lvl6pPr>
              <a:defRPr sz="1368"/>
            </a:lvl6pPr>
            <a:lvl7pPr>
              <a:defRPr sz="1368"/>
            </a:lvl7pPr>
            <a:lvl8pPr>
              <a:defRPr sz="1368"/>
            </a:lvl8pPr>
            <a:lvl9pPr>
              <a:defRPr sz="1368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0829" y="2537460"/>
            <a:ext cx="2017320" cy="4700959"/>
          </a:xfrm>
        </p:spPr>
        <p:txBody>
          <a:bodyPr/>
          <a:lstStyle>
            <a:lvl1pPr marL="0" indent="0">
              <a:buNone/>
              <a:defRPr sz="1094"/>
            </a:lvl1pPr>
            <a:lvl2pPr marL="312725" indent="0">
              <a:buNone/>
              <a:defRPr sz="958"/>
            </a:lvl2pPr>
            <a:lvl3pPr marL="625450" indent="0">
              <a:buNone/>
              <a:defRPr sz="821"/>
            </a:lvl3pPr>
            <a:lvl4pPr marL="938174" indent="0">
              <a:buNone/>
              <a:defRPr sz="684"/>
            </a:lvl4pPr>
            <a:lvl5pPr marL="1250899" indent="0">
              <a:buNone/>
              <a:defRPr sz="684"/>
            </a:lvl5pPr>
            <a:lvl6pPr marL="1563624" indent="0">
              <a:buNone/>
              <a:defRPr sz="684"/>
            </a:lvl6pPr>
            <a:lvl7pPr marL="1876349" indent="0">
              <a:buNone/>
              <a:defRPr sz="684"/>
            </a:lvl7pPr>
            <a:lvl8pPr marL="2189074" indent="0">
              <a:buNone/>
              <a:defRPr sz="684"/>
            </a:lvl8pPr>
            <a:lvl9pPr marL="2501798" indent="0">
              <a:buNone/>
              <a:defRPr sz="684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583E7-35CE-4CCC-88E2-B853881ACBA0}" type="datetimeFigureOut">
              <a:rPr lang="en-US" smtClean="0"/>
              <a:t>2/1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7E058-FEC0-4F0D-986D-6993D1123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08428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0829" y="563880"/>
            <a:ext cx="2017320" cy="1973580"/>
          </a:xfrm>
        </p:spPr>
        <p:txBody>
          <a:bodyPr anchor="b"/>
          <a:lstStyle>
            <a:lvl1pPr>
              <a:defRPr sz="218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59084" y="1217826"/>
            <a:ext cx="3166467" cy="6010804"/>
          </a:xfrm>
        </p:spPr>
        <p:txBody>
          <a:bodyPr anchor="t"/>
          <a:lstStyle>
            <a:lvl1pPr marL="0" indent="0">
              <a:buNone/>
              <a:defRPr sz="2189"/>
            </a:lvl1pPr>
            <a:lvl2pPr marL="312725" indent="0">
              <a:buNone/>
              <a:defRPr sz="1915"/>
            </a:lvl2pPr>
            <a:lvl3pPr marL="625450" indent="0">
              <a:buNone/>
              <a:defRPr sz="1642"/>
            </a:lvl3pPr>
            <a:lvl4pPr marL="938174" indent="0">
              <a:buNone/>
              <a:defRPr sz="1368"/>
            </a:lvl4pPr>
            <a:lvl5pPr marL="1250899" indent="0">
              <a:buNone/>
              <a:defRPr sz="1368"/>
            </a:lvl5pPr>
            <a:lvl6pPr marL="1563624" indent="0">
              <a:buNone/>
              <a:defRPr sz="1368"/>
            </a:lvl6pPr>
            <a:lvl7pPr marL="1876349" indent="0">
              <a:buNone/>
              <a:defRPr sz="1368"/>
            </a:lvl7pPr>
            <a:lvl8pPr marL="2189074" indent="0">
              <a:buNone/>
              <a:defRPr sz="1368"/>
            </a:lvl8pPr>
            <a:lvl9pPr marL="2501798" indent="0">
              <a:buNone/>
              <a:defRPr sz="1368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0829" y="2537460"/>
            <a:ext cx="2017320" cy="4700959"/>
          </a:xfrm>
        </p:spPr>
        <p:txBody>
          <a:bodyPr/>
          <a:lstStyle>
            <a:lvl1pPr marL="0" indent="0">
              <a:buNone/>
              <a:defRPr sz="1094"/>
            </a:lvl1pPr>
            <a:lvl2pPr marL="312725" indent="0">
              <a:buNone/>
              <a:defRPr sz="958"/>
            </a:lvl2pPr>
            <a:lvl3pPr marL="625450" indent="0">
              <a:buNone/>
              <a:defRPr sz="821"/>
            </a:lvl3pPr>
            <a:lvl4pPr marL="938174" indent="0">
              <a:buNone/>
              <a:defRPr sz="684"/>
            </a:lvl4pPr>
            <a:lvl5pPr marL="1250899" indent="0">
              <a:buNone/>
              <a:defRPr sz="684"/>
            </a:lvl5pPr>
            <a:lvl6pPr marL="1563624" indent="0">
              <a:buNone/>
              <a:defRPr sz="684"/>
            </a:lvl6pPr>
            <a:lvl7pPr marL="1876349" indent="0">
              <a:buNone/>
              <a:defRPr sz="684"/>
            </a:lvl7pPr>
            <a:lvl8pPr marL="2189074" indent="0">
              <a:buNone/>
              <a:defRPr sz="684"/>
            </a:lvl8pPr>
            <a:lvl9pPr marL="2501798" indent="0">
              <a:buNone/>
              <a:defRPr sz="684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583E7-35CE-4CCC-88E2-B853881ACBA0}" type="datetimeFigureOut">
              <a:rPr lang="en-US" smtClean="0"/>
              <a:t>2/1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7E058-FEC0-4F0D-986D-6993D1123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4037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30014" y="450323"/>
            <a:ext cx="5394722" cy="163486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0014" y="2251604"/>
            <a:ext cx="5394722" cy="53666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30014" y="7839500"/>
            <a:ext cx="1407319" cy="45032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2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D583E7-35CE-4CCC-88E2-B853881ACBA0}" type="datetimeFigureOut">
              <a:rPr lang="en-US" smtClean="0"/>
              <a:t>2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71886" y="7839500"/>
            <a:ext cx="2110978" cy="45032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2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417417" y="7839500"/>
            <a:ext cx="1407319" cy="45032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2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67E058-FEC0-4F0D-986D-6993D1123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62934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625450" rtl="0" eaLnBrk="1" latinLnBrk="0" hangingPunct="1">
        <a:lnSpc>
          <a:spcPct val="90000"/>
        </a:lnSpc>
        <a:spcBef>
          <a:spcPct val="0"/>
        </a:spcBef>
        <a:buNone/>
        <a:defRPr sz="301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6362" indent="-156362" algn="l" defTabSz="625450" rtl="0" eaLnBrk="1" latinLnBrk="0" hangingPunct="1">
        <a:lnSpc>
          <a:spcPct val="90000"/>
        </a:lnSpc>
        <a:spcBef>
          <a:spcPts val="684"/>
        </a:spcBef>
        <a:buFont typeface="Arial" panose="020B0604020202020204" pitchFamily="34" charset="0"/>
        <a:buChar char="•"/>
        <a:defRPr sz="1915" kern="1200">
          <a:solidFill>
            <a:schemeClr val="tx1"/>
          </a:solidFill>
          <a:latin typeface="+mn-lt"/>
          <a:ea typeface="+mn-ea"/>
          <a:cs typeface="+mn-cs"/>
        </a:defRPr>
      </a:lvl1pPr>
      <a:lvl2pPr marL="469087" indent="-156362" algn="l" defTabSz="625450" rtl="0" eaLnBrk="1" latinLnBrk="0" hangingPunct="1">
        <a:lnSpc>
          <a:spcPct val="90000"/>
        </a:lnSpc>
        <a:spcBef>
          <a:spcPts val="342"/>
        </a:spcBef>
        <a:buFont typeface="Arial" panose="020B0604020202020204" pitchFamily="34" charset="0"/>
        <a:buChar char="•"/>
        <a:defRPr sz="1642" kern="1200">
          <a:solidFill>
            <a:schemeClr val="tx1"/>
          </a:solidFill>
          <a:latin typeface="+mn-lt"/>
          <a:ea typeface="+mn-ea"/>
          <a:cs typeface="+mn-cs"/>
        </a:defRPr>
      </a:lvl2pPr>
      <a:lvl3pPr marL="781812" indent="-156362" algn="l" defTabSz="625450" rtl="0" eaLnBrk="1" latinLnBrk="0" hangingPunct="1">
        <a:lnSpc>
          <a:spcPct val="90000"/>
        </a:lnSpc>
        <a:spcBef>
          <a:spcPts val="342"/>
        </a:spcBef>
        <a:buFont typeface="Arial" panose="020B0604020202020204" pitchFamily="34" charset="0"/>
        <a:buChar char="•"/>
        <a:defRPr sz="1368" kern="1200">
          <a:solidFill>
            <a:schemeClr val="tx1"/>
          </a:solidFill>
          <a:latin typeface="+mn-lt"/>
          <a:ea typeface="+mn-ea"/>
          <a:cs typeface="+mn-cs"/>
        </a:defRPr>
      </a:lvl3pPr>
      <a:lvl4pPr marL="1094537" indent="-156362" algn="l" defTabSz="625450" rtl="0" eaLnBrk="1" latinLnBrk="0" hangingPunct="1">
        <a:lnSpc>
          <a:spcPct val="90000"/>
        </a:lnSpc>
        <a:spcBef>
          <a:spcPts val="342"/>
        </a:spcBef>
        <a:buFont typeface="Arial" panose="020B0604020202020204" pitchFamily="34" charset="0"/>
        <a:buChar char="•"/>
        <a:defRPr sz="1231" kern="1200">
          <a:solidFill>
            <a:schemeClr val="tx1"/>
          </a:solidFill>
          <a:latin typeface="+mn-lt"/>
          <a:ea typeface="+mn-ea"/>
          <a:cs typeface="+mn-cs"/>
        </a:defRPr>
      </a:lvl4pPr>
      <a:lvl5pPr marL="1407262" indent="-156362" algn="l" defTabSz="625450" rtl="0" eaLnBrk="1" latinLnBrk="0" hangingPunct="1">
        <a:lnSpc>
          <a:spcPct val="90000"/>
        </a:lnSpc>
        <a:spcBef>
          <a:spcPts val="342"/>
        </a:spcBef>
        <a:buFont typeface="Arial" panose="020B0604020202020204" pitchFamily="34" charset="0"/>
        <a:buChar char="•"/>
        <a:defRPr sz="1231" kern="1200">
          <a:solidFill>
            <a:schemeClr val="tx1"/>
          </a:solidFill>
          <a:latin typeface="+mn-lt"/>
          <a:ea typeface="+mn-ea"/>
          <a:cs typeface="+mn-cs"/>
        </a:defRPr>
      </a:lvl5pPr>
      <a:lvl6pPr marL="1719986" indent="-156362" algn="l" defTabSz="625450" rtl="0" eaLnBrk="1" latinLnBrk="0" hangingPunct="1">
        <a:lnSpc>
          <a:spcPct val="90000"/>
        </a:lnSpc>
        <a:spcBef>
          <a:spcPts val="342"/>
        </a:spcBef>
        <a:buFont typeface="Arial" panose="020B0604020202020204" pitchFamily="34" charset="0"/>
        <a:buChar char="•"/>
        <a:defRPr sz="1231" kern="1200">
          <a:solidFill>
            <a:schemeClr val="tx1"/>
          </a:solidFill>
          <a:latin typeface="+mn-lt"/>
          <a:ea typeface="+mn-ea"/>
          <a:cs typeface="+mn-cs"/>
        </a:defRPr>
      </a:lvl6pPr>
      <a:lvl7pPr marL="2032711" indent="-156362" algn="l" defTabSz="625450" rtl="0" eaLnBrk="1" latinLnBrk="0" hangingPunct="1">
        <a:lnSpc>
          <a:spcPct val="90000"/>
        </a:lnSpc>
        <a:spcBef>
          <a:spcPts val="342"/>
        </a:spcBef>
        <a:buFont typeface="Arial" panose="020B0604020202020204" pitchFamily="34" charset="0"/>
        <a:buChar char="•"/>
        <a:defRPr sz="1231" kern="1200">
          <a:solidFill>
            <a:schemeClr val="tx1"/>
          </a:solidFill>
          <a:latin typeface="+mn-lt"/>
          <a:ea typeface="+mn-ea"/>
          <a:cs typeface="+mn-cs"/>
        </a:defRPr>
      </a:lvl7pPr>
      <a:lvl8pPr marL="2345436" indent="-156362" algn="l" defTabSz="625450" rtl="0" eaLnBrk="1" latinLnBrk="0" hangingPunct="1">
        <a:lnSpc>
          <a:spcPct val="90000"/>
        </a:lnSpc>
        <a:spcBef>
          <a:spcPts val="342"/>
        </a:spcBef>
        <a:buFont typeface="Arial" panose="020B0604020202020204" pitchFamily="34" charset="0"/>
        <a:buChar char="•"/>
        <a:defRPr sz="1231" kern="1200">
          <a:solidFill>
            <a:schemeClr val="tx1"/>
          </a:solidFill>
          <a:latin typeface="+mn-lt"/>
          <a:ea typeface="+mn-ea"/>
          <a:cs typeface="+mn-cs"/>
        </a:defRPr>
      </a:lvl8pPr>
      <a:lvl9pPr marL="2658161" indent="-156362" algn="l" defTabSz="625450" rtl="0" eaLnBrk="1" latinLnBrk="0" hangingPunct="1">
        <a:lnSpc>
          <a:spcPct val="90000"/>
        </a:lnSpc>
        <a:spcBef>
          <a:spcPts val="342"/>
        </a:spcBef>
        <a:buFont typeface="Arial" panose="020B0604020202020204" pitchFamily="34" charset="0"/>
        <a:buChar char="•"/>
        <a:defRPr sz="123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25450" rtl="0" eaLnBrk="1" latinLnBrk="0" hangingPunct="1">
        <a:defRPr sz="1231" kern="1200">
          <a:solidFill>
            <a:schemeClr val="tx1"/>
          </a:solidFill>
          <a:latin typeface="+mn-lt"/>
          <a:ea typeface="+mn-ea"/>
          <a:cs typeface="+mn-cs"/>
        </a:defRPr>
      </a:lvl1pPr>
      <a:lvl2pPr marL="312725" algn="l" defTabSz="625450" rtl="0" eaLnBrk="1" latinLnBrk="0" hangingPunct="1">
        <a:defRPr sz="1231" kern="1200">
          <a:solidFill>
            <a:schemeClr val="tx1"/>
          </a:solidFill>
          <a:latin typeface="+mn-lt"/>
          <a:ea typeface="+mn-ea"/>
          <a:cs typeface="+mn-cs"/>
        </a:defRPr>
      </a:lvl2pPr>
      <a:lvl3pPr marL="625450" algn="l" defTabSz="625450" rtl="0" eaLnBrk="1" latinLnBrk="0" hangingPunct="1">
        <a:defRPr sz="1231" kern="1200">
          <a:solidFill>
            <a:schemeClr val="tx1"/>
          </a:solidFill>
          <a:latin typeface="+mn-lt"/>
          <a:ea typeface="+mn-ea"/>
          <a:cs typeface="+mn-cs"/>
        </a:defRPr>
      </a:lvl3pPr>
      <a:lvl4pPr marL="938174" algn="l" defTabSz="625450" rtl="0" eaLnBrk="1" latinLnBrk="0" hangingPunct="1">
        <a:defRPr sz="1231" kern="1200">
          <a:solidFill>
            <a:schemeClr val="tx1"/>
          </a:solidFill>
          <a:latin typeface="+mn-lt"/>
          <a:ea typeface="+mn-ea"/>
          <a:cs typeface="+mn-cs"/>
        </a:defRPr>
      </a:lvl4pPr>
      <a:lvl5pPr marL="1250899" algn="l" defTabSz="625450" rtl="0" eaLnBrk="1" latinLnBrk="0" hangingPunct="1">
        <a:defRPr sz="1231" kern="1200">
          <a:solidFill>
            <a:schemeClr val="tx1"/>
          </a:solidFill>
          <a:latin typeface="+mn-lt"/>
          <a:ea typeface="+mn-ea"/>
          <a:cs typeface="+mn-cs"/>
        </a:defRPr>
      </a:lvl5pPr>
      <a:lvl6pPr marL="1563624" algn="l" defTabSz="625450" rtl="0" eaLnBrk="1" latinLnBrk="0" hangingPunct="1">
        <a:defRPr sz="1231" kern="1200">
          <a:solidFill>
            <a:schemeClr val="tx1"/>
          </a:solidFill>
          <a:latin typeface="+mn-lt"/>
          <a:ea typeface="+mn-ea"/>
          <a:cs typeface="+mn-cs"/>
        </a:defRPr>
      </a:lvl6pPr>
      <a:lvl7pPr marL="1876349" algn="l" defTabSz="625450" rtl="0" eaLnBrk="1" latinLnBrk="0" hangingPunct="1">
        <a:defRPr sz="1231" kern="1200">
          <a:solidFill>
            <a:schemeClr val="tx1"/>
          </a:solidFill>
          <a:latin typeface="+mn-lt"/>
          <a:ea typeface="+mn-ea"/>
          <a:cs typeface="+mn-cs"/>
        </a:defRPr>
      </a:lvl7pPr>
      <a:lvl8pPr marL="2189074" algn="l" defTabSz="625450" rtl="0" eaLnBrk="1" latinLnBrk="0" hangingPunct="1">
        <a:defRPr sz="1231" kern="1200">
          <a:solidFill>
            <a:schemeClr val="tx1"/>
          </a:solidFill>
          <a:latin typeface="+mn-lt"/>
          <a:ea typeface="+mn-ea"/>
          <a:cs typeface="+mn-cs"/>
        </a:defRPr>
      </a:lvl8pPr>
      <a:lvl9pPr marL="2501798" algn="l" defTabSz="625450" rtl="0" eaLnBrk="1" latinLnBrk="0" hangingPunct="1">
        <a:defRPr sz="123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TextBox 107"/>
          <p:cNvSpPr txBox="1"/>
          <p:nvPr/>
        </p:nvSpPr>
        <p:spPr>
          <a:xfrm>
            <a:off x="101672" y="127276"/>
            <a:ext cx="288412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Shahriary et al.- Supplementary Figure 3</a:t>
            </a:r>
          </a:p>
        </p:txBody>
      </p:sp>
      <p:sp>
        <p:nvSpPr>
          <p:cNvPr id="15" name="TextBox 14"/>
          <p:cNvSpPr txBox="1"/>
          <p:nvPr/>
        </p:nvSpPr>
        <p:spPr>
          <a:xfrm rot="18148423">
            <a:off x="2416671" y="1057833"/>
            <a:ext cx="1607382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TNF-</a:t>
            </a:r>
            <a:r>
              <a:rPr lang="el-GR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α</a:t>
            </a: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 peptide</a:t>
            </a:r>
          </a:p>
          <a:p>
            <a:pPr algn="ctr"/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(</a:t>
            </a:r>
            <a:r>
              <a:rPr lang="en-CA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1ug/ml )</a:t>
            </a:r>
          </a:p>
        </p:txBody>
      </p:sp>
      <p:grpSp>
        <p:nvGrpSpPr>
          <p:cNvPr id="35" name="Group 34"/>
          <p:cNvGrpSpPr/>
          <p:nvPr/>
        </p:nvGrpSpPr>
        <p:grpSpPr>
          <a:xfrm>
            <a:off x="609743" y="696836"/>
            <a:ext cx="4034039" cy="1978151"/>
            <a:chOff x="609743" y="696836"/>
            <a:chExt cx="4034039" cy="1978151"/>
          </a:xfrm>
        </p:grpSpPr>
        <p:sp>
          <p:nvSpPr>
            <p:cNvPr id="5" name="TextBox 4"/>
            <p:cNvSpPr txBox="1"/>
            <p:nvPr/>
          </p:nvSpPr>
          <p:spPr>
            <a:xfrm>
              <a:off x="609743" y="802547"/>
              <a:ext cx="46280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(a)</a:t>
              </a:r>
            </a:p>
          </p:txBody>
        </p:sp>
        <p:sp>
          <p:nvSpPr>
            <p:cNvPr id="2" name="TextBox 1"/>
            <p:cNvSpPr txBox="1"/>
            <p:nvPr/>
          </p:nvSpPr>
          <p:spPr>
            <a:xfrm>
              <a:off x="836362" y="800530"/>
              <a:ext cx="63030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2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TNF-</a:t>
              </a:r>
              <a:r>
                <a:rPr lang="el-GR" sz="12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α</a:t>
              </a:r>
              <a:endParaRPr lang="en-US" sz="1200" b="1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263536" y="1618684"/>
              <a:ext cx="2349931" cy="506419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263537" y="2179964"/>
              <a:ext cx="2349931" cy="480497"/>
            </a:xfrm>
            <a:prstGeom prst="rect">
              <a:avLst/>
            </a:prstGeom>
          </p:spPr>
        </p:pic>
        <p:sp>
          <p:nvSpPr>
            <p:cNvPr id="12" name="TextBox 11"/>
            <p:cNvSpPr txBox="1"/>
            <p:nvPr/>
          </p:nvSpPr>
          <p:spPr>
            <a:xfrm rot="18268812">
              <a:off x="2168039" y="1033467"/>
              <a:ext cx="1088760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0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TNF-</a:t>
              </a:r>
              <a:r>
                <a:rPr lang="el-GR" sz="10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α</a:t>
              </a:r>
              <a:r>
                <a:rPr lang="en-US" sz="10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 peptide</a:t>
              </a:r>
            </a:p>
            <a:p>
              <a:pPr algn="ctr"/>
              <a:r>
                <a:rPr lang="en-CA" sz="10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(100ng/ml)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 rot="18148423">
              <a:off x="3197150" y="1103014"/>
              <a:ext cx="98646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000" b="1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RMCM</a:t>
              </a:r>
              <a:endParaRPr lang="en-CA" sz="1000" b="1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 rot="18148423">
              <a:off x="3581058" y="1105297"/>
              <a:ext cx="10236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000" b="1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PMCM (24h</a:t>
              </a:r>
              <a:r>
                <a:rPr lang="en-CA" sz="10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)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 rot="18148423">
              <a:off x="4016868" y="1114258"/>
              <a:ext cx="999911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000" b="1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PMCM (72h</a:t>
              </a:r>
              <a:r>
                <a:rPr lang="en-CA" sz="10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)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1478207" y="1564842"/>
              <a:ext cx="835485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Pro TNF-</a:t>
              </a:r>
              <a:r>
                <a:rPr lang="el-GR" sz="1000" b="1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α</a:t>
              </a:r>
              <a:endParaRPr lang="en-US" sz="1000" b="1" dirty="0" smtClean="0">
                <a:latin typeface="Helvetica" panose="020B0604020202020204" pitchFamily="34" charset="0"/>
                <a:cs typeface="Helvetica" panose="020B0604020202020204" pitchFamily="34" charset="0"/>
              </a:endParaRPr>
            </a:p>
            <a:p>
              <a:pPr algn="ctr"/>
              <a:r>
                <a:rPr lang="en-US" sz="1000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26kDa</a:t>
              </a:r>
              <a:endParaRPr lang="en-US" sz="100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313862" y="1897160"/>
              <a:ext cx="97494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Active</a:t>
              </a:r>
              <a:r>
                <a:rPr lang="en-US" sz="1000" b="1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n-US" sz="1000" b="1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TNF-</a:t>
              </a:r>
              <a:r>
                <a:rPr lang="el-GR" sz="1000" b="1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α</a:t>
              </a:r>
              <a:endParaRPr lang="en-US" sz="1000" b="1" dirty="0" smtClean="0">
                <a:latin typeface="Helvetica" panose="020B0604020202020204" pitchFamily="34" charset="0"/>
                <a:cs typeface="Helvetica" panose="020B0604020202020204" pitchFamily="34" charset="0"/>
              </a:endParaRPr>
            </a:p>
            <a:p>
              <a:pPr algn="ctr"/>
              <a:r>
                <a:rPr lang="en-US" sz="1000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     17kDa</a:t>
              </a:r>
              <a:endParaRPr lang="en-US" sz="100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1327808" y="2259489"/>
              <a:ext cx="997389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Total protein</a:t>
              </a:r>
            </a:p>
            <a:p>
              <a:pPr algn="ctr"/>
              <a:r>
                <a:rPr lang="en-US" sz="1000" dirty="0" err="1" smtClean="0">
                  <a:latin typeface="Helvetica" panose="020B0604020202020204" pitchFamily="34" charset="0"/>
                  <a:cs typeface="Helvetica" panose="020B0604020202020204" pitchFamily="34" charset="0"/>
                </a:rPr>
                <a:t>Ponceau</a:t>
              </a:r>
              <a:r>
                <a:rPr lang="en-US" sz="1000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 S</a:t>
              </a:r>
              <a:endParaRPr lang="en-US" sz="100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</p:grpSp>
      <p:grpSp>
        <p:nvGrpSpPr>
          <p:cNvPr id="38" name="Group 37"/>
          <p:cNvGrpSpPr/>
          <p:nvPr/>
        </p:nvGrpSpPr>
        <p:grpSpPr>
          <a:xfrm>
            <a:off x="628793" y="3271478"/>
            <a:ext cx="4227474" cy="2679702"/>
            <a:chOff x="628793" y="3271478"/>
            <a:chExt cx="4227474" cy="2679702"/>
          </a:xfrm>
        </p:grpSpPr>
        <p:sp>
          <p:nvSpPr>
            <p:cNvPr id="36" name="TextBox 35"/>
            <p:cNvSpPr txBox="1"/>
            <p:nvPr/>
          </p:nvSpPr>
          <p:spPr>
            <a:xfrm flipH="1">
              <a:off x="628793" y="3303662"/>
              <a:ext cx="44720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(b)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872775" y="3300878"/>
              <a:ext cx="54854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2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IFN-</a:t>
              </a:r>
              <a:r>
                <a:rPr lang="en-CA" sz="1200" b="1" dirty="0">
                  <a:latin typeface="Helvetica" panose="020B0604020202020204" pitchFamily="34" charset="0"/>
                  <a:cs typeface="Helvetica" panose="020B0604020202020204" pitchFamily="34" charset="0"/>
                  <a:sym typeface="Symbol" panose="05050102010706020507" pitchFamily="18" charset="2"/>
                </a:rPr>
                <a:t></a:t>
              </a:r>
              <a:endParaRPr lang="en-US" sz="1200" b="1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grpSp>
          <p:nvGrpSpPr>
            <p:cNvPr id="30" name="Group 29"/>
            <p:cNvGrpSpPr/>
            <p:nvPr/>
          </p:nvGrpSpPr>
          <p:grpSpPr>
            <a:xfrm>
              <a:off x="860743" y="3271478"/>
              <a:ext cx="3995524" cy="2679702"/>
              <a:chOff x="4301811" y="3364139"/>
              <a:chExt cx="3995524" cy="2679702"/>
            </a:xfrm>
          </p:grpSpPr>
          <p:pic>
            <p:nvPicPr>
              <p:cNvPr id="17" name="Picture 16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5228798" y="4536581"/>
                <a:ext cx="3055204" cy="500156"/>
              </a:xfrm>
              <a:prstGeom prst="rect">
                <a:avLst/>
              </a:prstGeom>
            </p:spPr>
          </p:pic>
          <p:pic>
            <p:nvPicPr>
              <p:cNvPr id="20" name="Picture 19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5228798" y="5101875"/>
                <a:ext cx="3064270" cy="345563"/>
              </a:xfrm>
              <a:prstGeom prst="rect">
                <a:avLst/>
              </a:prstGeom>
            </p:spPr>
          </p:pic>
          <p:sp>
            <p:nvSpPr>
              <p:cNvPr id="23" name="TextBox 22"/>
              <p:cNvSpPr txBox="1"/>
              <p:nvPr/>
            </p:nvSpPr>
            <p:spPr>
              <a:xfrm rot="18268812">
                <a:off x="5086221" y="3905269"/>
                <a:ext cx="1040670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IFN</a:t>
                </a:r>
                <a:r>
                  <a:rPr lang="en-US" sz="12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-</a:t>
                </a:r>
                <a:r>
                  <a:rPr lang="en-CA" sz="1050" b="1" dirty="0" smtClean="0">
                    <a:latin typeface="Helvetica" panose="020B0604020202020204" pitchFamily="34" charset="0"/>
                    <a:cs typeface="Helvetica" panose="020B0604020202020204" pitchFamily="34" charset="0"/>
                    <a:sym typeface="Symbol" panose="05050102010706020507" pitchFamily="18" charset="2"/>
                  </a:rPr>
                  <a:t></a:t>
                </a:r>
                <a:r>
                  <a:rPr lang="en-US" sz="1050" b="1" dirty="0" smtClean="0">
                    <a:latin typeface="Helvetica" panose="020B0604020202020204" pitchFamily="34" charset="0"/>
                    <a:cs typeface="Helvetica" panose="020B0604020202020204" pitchFamily="34" charset="0"/>
                    <a:sym typeface="Symbol" panose="05050102010706020507" pitchFamily="18" charset="2"/>
                  </a:rPr>
                  <a:t> </a:t>
                </a:r>
                <a:r>
                  <a:rPr lang="en-US" sz="10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 </a:t>
                </a:r>
                <a:r>
                  <a:rPr lang="en-US" sz="10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peptide</a:t>
                </a:r>
              </a:p>
              <a:p>
                <a:pPr algn="ctr"/>
                <a:r>
                  <a:rPr lang="en-CA" sz="10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(50 ng/ml</a:t>
                </a:r>
                <a:r>
                  <a:rPr lang="en-CA" sz="10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)</a:t>
                </a:r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 rot="18148423">
                <a:off x="6656411" y="4007361"/>
                <a:ext cx="986467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10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RMCM</a:t>
                </a:r>
                <a:endParaRPr lang="en-CA" sz="10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 rot="18148423">
                <a:off x="7145832" y="3997601"/>
                <a:ext cx="102362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10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PMCM (24h</a:t>
                </a:r>
                <a:r>
                  <a:rPr lang="en-CA" sz="10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)</a:t>
                </a:r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 rot="18148423">
                <a:off x="5272765" y="4044719"/>
                <a:ext cx="160738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EAE sample</a:t>
                </a:r>
                <a:endParaRPr lang="en-CA" sz="10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 rot="18148423">
                <a:off x="7670421" y="3986519"/>
                <a:ext cx="999911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10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PMCM (72h</a:t>
                </a:r>
                <a:r>
                  <a:rPr lang="en-CA" sz="10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)</a:t>
                </a:r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 rot="18148423">
                <a:off x="5774035" y="4053226"/>
                <a:ext cx="160738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EAE sample</a:t>
                </a:r>
                <a:endParaRPr lang="en-CA" sz="10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>
                <a:off x="4688590" y="4261785"/>
                <a:ext cx="502061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05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IFN-</a:t>
                </a:r>
                <a:r>
                  <a:rPr lang="en-CA" sz="1050" b="1" dirty="0">
                    <a:latin typeface="Helvetica" panose="020B0604020202020204" pitchFamily="34" charset="0"/>
                    <a:cs typeface="Helvetica" panose="020B0604020202020204" pitchFamily="34" charset="0"/>
                    <a:sym typeface="Symbol" panose="05050102010706020507" pitchFamily="18" charset="2"/>
                  </a:rPr>
                  <a:t></a:t>
                </a:r>
                <a:endParaRPr lang="en-US" sz="105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4687685" y="4501714"/>
                <a:ext cx="5533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45kDa</a:t>
                </a:r>
                <a:endParaRPr lang="en-US" sz="1000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4687686" y="4654985"/>
                <a:ext cx="5533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31kDa</a:t>
                </a:r>
                <a:endParaRPr lang="en-US" sz="1000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4693416" y="4827038"/>
                <a:ext cx="5533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25kDa</a:t>
                </a:r>
                <a:endParaRPr lang="en-US" sz="1000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4603630" y="5084517"/>
                <a:ext cx="671979" cy="4154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0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GAPDH</a:t>
                </a:r>
              </a:p>
              <a:p>
                <a:pPr algn="ctr"/>
                <a:r>
                  <a:rPr lang="en-CA" sz="1000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37kDa</a:t>
                </a:r>
                <a:endParaRPr lang="en-US" sz="1000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pic>
            <p:nvPicPr>
              <p:cNvPr id="22" name="Picture 21"/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5228798" y="5516403"/>
                <a:ext cx="3064270" cy="527438"/>
              </a:xfrm>
              <a:prstGeom prst="rect">
                <a:avLst/>
              </a:prstGeom>
            </p:spPr>
          </p:pic>
          <p:sp>
            <p:nvSpPr>
              <p:cNvPr id="37" name="TextBox 36"/>
              <p:cNvSpPr txBox="1"/>
              <p:nvPr/>
            </p:nvSpPr>
            <p:spPr>
              <a:xfrm>
                <a:off x="4301811" y="5568224"/>
                <a:ext cx="997389" cy="4154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Total protein</a:t>
                </a:r>
              </a:p>
              <a:p>
                <a:pPr algn="ctr"/>
                <a:r>
                  <a:rPr lang="en-US" sz="1000" dirty="0" err="1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Ponceau</a:t>
                </a:r>
                <a:r>
                  <a:rPr lang="en-US" sz="1000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 S</a:t>
                </a:r>
                <a:endParaRPr lang="en-US" sz="1000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5765136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095</TotalTime>
  <Words>82</Words>
  <Application>Microsoft Office PowerPoint</Application>
  <PresentationFormat>Custom</PresentationFormat>
  <Paragraphs>3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Helvetica</vt:lpstr>
      <vt:lpstr>Symbol</vt:lpstr>
      <vt:lpstr>Office Theme</vt:lpstr>
      <vt:lpstr>PowerPoint Presentation</vt:lpstr>
    </vt:vector>
  </TitlesOfParts>
  <Company>MRT www.Win2Farsi.co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USER</cp:lastModifiedBy>
  <cp:revision>1035</cp:revision>
  <cp:lastPrinted>2019-02-02T05:56:56Z</cp:lastPrinted>
  <dcterms:created xsi:type="dcterms:W3CDTF">2018-08-01T14:08:28Z</dcterms:created>
  <dcterms:modified xsi:type="dcterms:W3CDTF">2019-02-14T03:16:36Z</dcterms:modified>
</cp:coreProperties>
</file>